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4"/>
  </p:sldMasterIdLst>
  <p:sldIdLst>
    <p:sldId id="265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00"/>
    <a:srgbClr val="00FFCC"/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396" autoAdjust="0"/>
    <p:restoredTop sz="94660"/>
  </p:normalViewPr>
  <p:slideViewPr>
    <p:cSldViewPr snapToGrid="0">
      <p:cViewPr varScale="1">
        <p:scale>
          <a:sx n="85" d="100"/>
          <a:sy n="85" d="100"/>
        </p:scale>
        <p:origin x="3536" y="1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LADIO ANDRES VELASCO SAMPEDRO" userId="4fe01f26-2daf-4667-9ff9-7ff51236cc21" providerId="ADAL" clId="{B3A2E5C3-5DA0-428D-901C-8EA7236A38F1}"/>
    <pc:docChg chg="undo delSld modSld">
      <pc:chgData name="ELADIO ANDRES VELASCO SAMPEDRO" userId="4fe01f26-2daf-4667-9ff9-7ff51236cc21" providerId="ADAL" clId="{B3A2E5C3-5DA0-428D-901C-8EA7236A38F1}" dt="2024-11-29T13:41:30.581" v="441" actId="20577"/>
      <pc:docMkLst>
        <pc:docMk/>
      </pc:docMkLst>
      <pc:sldChg chg="addSp delSp modSp">
        <pc:chgData name="ELADIO ANDRES VELASCO SAMPEDRO" userId="4fe01f26-2daf-4667-9ff9-7ff51236cc21" providerId="ADAL" clId="{B3A2E5C3-5DA0-428D-901C-8EA7236A38F1}" dt="2024-11-29T13:41:30.581" v="441" actId="20577"/>
        <pc:sldMkLst>
          <pc:docMk/>
          <pc:sldMk cId="2471961744" sldId="265"/>
        </pc:sldMkLst>
        <pc:spChg chg="mod topLvl">
          <ac:chgData name="ELADIO ANDRES VELASCO SAMPEDRO" userId="4fe01f26-2daf-4667-9ff9-7ff51236cc21" providerId="ADAL" clId="{B3A2E5C3-5DA0-428D-901C-8EA7236A38F1}" dt="2024-11-29T11:46:03.674" v="432" actId="164"/>
          <ac:spMkLst>
            <pc:docMk/>
            <pc:sldMk cId="2471961744" sldId="265"/>
            <ac:spMk id="4" creationId="{00000000-0000-0000-0000-000000000000}"/>
          </ac:spMkLst>
        </pc:spChg>
        <pc:spChg chg="mod topLvl">
          <ac:chgData name="ELADIO ANDRES VELASCO SAMPEDRO" userId="4fe01f26-2daf-4667-9ff9-7ff51236cc21" providerId="ADAL" clId="{B3A2E5C3-5DA0-428D-901C-8EA7236A38F1}" dt="2024-11-29T11:46:03.674" v="432" actId="164"/>
          <ac:spMkLst>
            <pc:docMk/>
            <pc:sldMk cId="2471961744" sldId="265"/>
            <ac:spMk id="5" creationId="{00000000-0000-0000-0000-000000000000}"/>
          </ac:spMkLst>
        </pc:spChg>
        <pc:spChg chg="mod topLvl">
          <ac:chgData name="ELADIO ANDRES VELASCO SAMPEDRO" userId="4fe01f26-2daf-4667-9ff9-7ff51236cc21" providerId="ADAL" clId="{B3A2E5C3-5DA0-428D-901C-8EA7236A38F1}" dt="2024-11-29T11:46:03.674" v="432" actId="164"/>
          <ac:spMkLst>
            <pc:docMk/>
            <pc:sldMk cId="2471961744" sldId="265"/>
            <ac:spMk id="6" creationId="{00000000-0000-0000-0000-000000000000}"/>
          </ac:spMkLst>
        </pc:spChg>
        <pc:spChg chg="mod topLvl">
          <ac:chgData name="ELADIO ANDRES VELASCO SAMPEDRO" userId="4fe01f26-2daf-4667-9ff9-7ff51236cc21" providerId="ADAL" clId="{B3A2E5C3-5DA0-428D-901C-8EA7236A38F1}" dt="2024-11-29T11:46:03.674" v="432" actId="164"/>
          <ac:spMkLst>
            <pc:docMk/>
            <pc:sldMk cId="2471961744" sldId="265"/>
            <ac:spMk id="7" creationId="{00000000-0000-0000-0000-000000000000}"/>
          </ac:spMkLst>
        </pc:spChg>
        <pc:spChg chg="mod topLvl">
          <ac:chgData name="ELADIO ANDRES VELASCO SAMPEDRO" userId="4fe01f26-2daf-4667-9ff9-7ff51236cc21" providerId="ADAL" clId="{B3A2E5C3-5DA0-428D-901C-8EA7236A38F1}" dt="2024-11-29T11:46:03.674" v="432" actId="164"/>
          <ac:spMkLst>
            <pc:docMk/>
            <pc:sldMk cId="2471961744" sldId="265"/>
            <ac:spMk id="8" creationId="{00000000-0000-0000-0000-000000000000}"/>
          </ac:spMkLst>
        </pc:spChg>
        <pc:spChg chg="mod topLvl">
          <ac:chgData name="ELADIO ANDRES VELASCO SAMPEDRO" userId="4fe01f26-2daf-4667-9ff9-7ff51236cc21" providerId="ADAL" clId="{B3A2E5C3-5DA0-428D-901C-8EA7236A38F1}" dt="2024-11-29T11:46:03.674" v="432" actId="164"/>
          <ac:spMkLst>
            <pc:docMk/>
            <pc:sldMk cId="2471961744" sldId="265"/>
            <ac:spMk id="9" creationId="{00000000-0000-0000-0000-000000000000}"/>
          </ac:spMkLst>
        </pc:spChg>
        <pc:spChg chg="mod topLvl">
          <ac:chgData name="ELADIO ANDRES VELASCO SAMPEDRO" userId="4fe01f26-2daf-4667-9ff9-7ff51236cc21" providerId="ADAL" clId="{B3A2E5C3-5DA0-428D-901C-8EA7236A38F1}" dt="2024-11-29T11:46:03.674" v="432" actId="164"/>
          <ac:spMkLst>
            <pc:docMk/>
            <pc:sldMk cId="2471961744" sldId="265"/>
            <ac:spMk id="10" creationId="{00000000-0000-0000-0000-000000000000}"/>
          </ac:spMkLst>
        </pc:spChg>
        <pc:spChg chg="mod">
          <ac:chgData name="ELADIO ANDRES VELASCO SAMPEDRO" userId="4fe01f26-2daf-4667-9ff9-7ff51236cc21" providerId="ADAL" clId="{B3A2E5C3-5DA0-428D-901C-8EA7236A38F1}" dt="2024-11-29T11:46:03.674" v="432" actId="164"/>
          <ac:spMkLst>
            <pc:docMk/>
            <pc:sldMk cId="2471961744" sldId="265"/>
            <ac:spMk id="31" creationId="{F448F2C2-33D4-4677-BC80-5BB9CDEB36C2}"/>
          </ac:spMkLst>
        </pc:spChg>
        <pc:spChg chg="mod">
          <ac:chgData name="ELADIO ANDRES VELASCO SAMPEDRO" userId="4fe01f26-2daf-4667-9ff9-7ff51236cc21" providerId="ADAL" clId="{B3A2E5C3-5DA0-428D-901C-8EA7236A38F1}" dt="2024-11-29T11:46:03.674" v="432" actId="164"/>
          <ac:spMkLst>
            <pc:docMk/>
            <pc:sldMk cId="2471961744" sldId="265"/>
            <ac:spMk id="32" creationId="{7FC3A130-E448-444F-ABA0-8B5037FE1603}"/>
          </ac:spMkLst>
        </pc:spChg>
        <pc:spChg chg="mod">
          <ac:chgData name="ELADIO ANDRES VELASCO SAMPEDRO" userId="4fe01f26-2daf-4667-9ff9-7ff51236cc21" providerId="ADAL" clId="{B3A2E5C3-5DA0-428D-901C-8EA7236A38F1}" dt="2024-11-29T13:41:30.581" v="441" actId="20577"/>
          <ac:spMkLst>
            <pc:docMk/>
            <pc:sldMk cId="2471961744" sldId="265"/>
            <ac:spMk id="33" creationId="{FBA64584-40F1-4FE7-BF34-7B142FBE1BB5}"/>
          </ac:spMkLst>
        </pc:spChg>
        <pc:grpChg chg="add mod">
          <ac:chgData name="ELADIO ANDRES VELASCO SAMPEDRO" userId="4fe01f26-2daf-4667-9ff9-7ff51236cc21" providerId="ADAL" clId="{B3A2E5C3-5DA0-428D-901C-8EA7236A38F1}" dt="2024-11-29T11:46:03.674" v="432" actId="164"/>
          <ac:grpSpMkLst>
            <pc:docMk/>
            <pc:sldMk cId="2471961744" sldId="265"/>
            <ac:grpSpMk id="2" creationId="{3AD05748-FA29-4710-8D32-FDC0ACD17A9B}"/>
          </ac:grpSpMkLst>
        </pc:grpChg>
        <pc:grpChg chg="del mod">
          <ac:chgData name="ELADIO ANDRES VELASCO SAMPEDRO" userId="4fe01f26-2daf-4667-9ff9-7ff51236cc21" providerId="ADAL" clId="{B3A2E5C3-5DA0-428D-901C-8EA7236A38F1}" dt="2024-11-29T10:10:36.766" v="160" actId="165"/>
          <ac:grpSpMkLst>
            <pc:docMk/>
            <pc:sldMk cId="2471961744" sldId="265"/>
            <ac:grpSpMk id="16" creationId="{00000000-0000-0000-0000-000000000000}"/>
          </ac:grpSpMkLst>
        </pc:grpChg>
      </pc:sldChg>
      <pc:sldChg chg="del">
        <pc:chgData name="ELADIO ANDRES VELASCO SAMPEDRO" userId="4fe01f26-2daf-4667-9ff9-7ff51236cc21" providerId="ADAL" clId="{B3A2E5C3-5DA0-428D-901C-8EA7236A38F1}" dt="2024-11-29T10:05:38.601" v="0" actId="2696"/>
        <pc:sldMkLst>
          <pc:docMk/>
          <pc:sldMk cId="3319554440" sldId="267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10/12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568431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10/12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48544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10/12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672401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10/12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597341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10/12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034517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10/12/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512349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10/12/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95129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10/12/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064015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10/12/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438980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10/12/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01146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B25EC-3591-47B7-A979-3FEFA6BE234C}" type="datetimeFigureOut">
              <a:rPr lang="es-ES" smtClean="0"/>
              <a:t>10/12/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F9546-536E-4B3C-BCEC-36093433FD2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039160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2B25EC-3591-47B7-A979-3FEFA6BE234C}" type="datetimeFigureOut">
              <a:rPr lang="es-ES" smtClean="0"/>
              <a:t>10/12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FF9546-536E-4B3C-BCEC-36093433FD2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286676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3AD05748-FA29-4710-8D32-FDC0ACD17A9B}"/>
              </a:ext>
            </a:extLst>
          </p:cNvPr>
          <p:cNvGrpSpPr/>
          <p:nvPr/>
        </p:nvGrpSpPr>
        <p:grpSpPr>
          <a:xfrm>
            <a:off x="659317" y="1225992"/>
            <a:ext cx="5766262" cy="8556188"/>
            <a:chOff x="659317" y="206665"/>
            <a:chExt cx="5766262" cy="8556188"/>
          </a:xfrm>
        </p:grpSpPr>
        <p:sp>
          <p:nvSpPr>
            <p:cNvPr id="4" name="Rectangle 3"/>
            <p:cNvSpPr/>
            <p:nvPr/>
          </p:nvSpPr>
          <p:spPr>
            <a:xfrm>
              <a:off x="659317" y="206665"/>
              <a:ext cx="5341138" cy="855618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s-ES" sz="1000" b="1" dirty="0">
                  <a:solidFill>
                    <a:srgbClr val="538135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 </a:t>
              </a:r>
              <a:r>
                <a:rPr lang="es-ES" sz="1000" b="1" dirty="0" err="1">
                  <a:solidFill>
                    <a:schemeClr val="accent1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SacI</a:t>
              </a:r>
              <a:endParaRPr lang="es-ES" sz="1000" b="1" u="heavy" dirty="0">
                <a:solidFill>
                  <a:schemeClr val="accent1"/>
                </a:solidFill>
                <a:effectLst/>
                <a:latin typeface="Courier New" panose="02070309020205020404" pitchFamily="49" charset="0"/>
                <a:ea typeface="Cascadia Code" panose="020B0609020000020004" pitchFamily="49" charset="0"/>
                <a:cs typeface="Courier New" panose="02070309020205020404" pitchFamily="49" charset="0"/>
              </a:endParaRPr>
            </a:p>
            <a:p>
              <a:pPr algn="just"/>
              <a:r>
                <a:rPr lang="es-ES" sz="1000" b="1" dirty="0">
                  <a:solidFill>
                    <a:schemeClr val="accent1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AGCTC</a:t>
              </a:r>
              <a:r>
                <a:rPr lang="es-ES" sz="1000" dirty="0"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cttgggttgtggtgaaacattggaagagagaatgtgaagcagccattcttttcctgctccacaggaagccgagctgtctcagacactggcatggtgttgggggagggggttccttctctgcaggcccaggtgacccagggttggaagtgtctcatgctggatccccacttttcctcttgcag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CAGCCAGACTGCCTTCCGGGTCACTGCCATGGAGGAGCCGCAGTCAGATCCTAGCGTCGAGCCCCCTCTGAGT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C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AGG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A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AACATTTTCAGACCTATGGAAACT</a:t>
              </a:r>
              <a:r>
                <a:rPr lang="es-ES" sz="1000" dirty="0"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tgagtggatccattggaagggcaggcccaccacccccaccccaaccccagccccctagcagagacctgtgggaagcgaaaattccatgggactgactttctgctcttgtctttcag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ACTTCCTGAAAACAACGTTCTG</a:t>
              </a:r>
              <a:r>
                <a:rPr lang="es-ES" sz="1000" dirty="0"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taaggacaagggttgggctggggacctggagggctggggacctggagggctggggggctggggggctgaggacctggtcctctgactgctcttttcacccatctaca</a:t>
              </a:r>
              <a:r>
                <a:rPr lang="es-ES" sz="1000" dirty="0"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TCCCCCTTGCCGTCCCA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A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CAATGGATGATTTGATGCTGTCCCCGGACGATATTGAACAATGGTTCACTGAAGACCCAGGT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C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CAG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A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TGAAGCTCCCAGAATGCCAGAGG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C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TGCTCCCCCCGTGGCCCCTGCACCAGCAG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C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TCCTACACCGGCGGCCCCTGCACCAGCCCCCTCCTGGCCCCTGTCATCTTCTGTCCCTTCCCAGAAAACCTACCAGG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C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AG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C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TACGGT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T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TCCGTCTGGGCTTCTTGCATTCTGGGACAGCCAAGT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C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TGTGA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C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TTGCA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C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</a:t>
              </a:r>
              <a:r>
                <a:rPr lang="es-ES" sz="1000" dirty="0"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tcagttgccctgaggggctggcttccatgagacttcaatgcctggccgtatccccctgcatttcttttgtttggaactttgggattcctcttcaccctttggcttcctgtcagtgtttttttatagtttacccacttaatgtgtgatctctgactcctgtcccaaagttgaatattccccccttgaatttgggcttttatccatcccatcacaccctcagcatctctcctggggatgcagaacttttctttttcttcatccacgtgtattccttggcttttgaaaataagctcct</a:t>
              </a:r>
              <a:r>
                <a:rPr lang="es-ES" sz="100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accaggcttggtggctcacacctgcaatcccagcactctcaaagaggccaaggcaggcagatcacctgagcccaggagttcaagaccagcctgggtaacatgatgaaacctcgtctctacaaaaaaatacaaaaaattagccaggcatggtggtgcacacctatagtcccagccacttaggaggctgaggtgggaagatcacttgaggccaggagatggaggctgcagtgagctgtgatcacaccactgtgctccagcctgagtgacagagcaagaccctatctcaaaaaaaaaaaaaaaaaagaaaa</a:t>
              </a:r>
              <a:r>
                <a:rPr lang="es-ES" sz="1000" dirty="0"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ctcctgaggtgtagacgccaactctctctagctcgctagtgggttgcaggaggtgcttacgcatgtttgtttctttgctgccgtcttccagttgctttatctgttcacttgtgccctgactttcaactctgtctccttcctcttcctaca</a:t>
              </a:r>
              <a:r>
                <a:rPr lang="es-ES" sz="1000" dirty="0"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TACTCCCCTGCCCTCAACAAGATGTTTTGCCAAC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T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GCCAAGACCTGCCCTGTGCAGCTGTGGGTTGATTCCACACCCCCGCCCGGCACCCGCGTCCGCGCCATGGCCATCTACAAGCAGTCACAGCACATGACGGAGGT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T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TGAGGCGCTGCCCCCACCATGAGCGCTGCTCAG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A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TAGCGAT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</a:t>
              </a:r>
              <a:r>
                <a:rPr lang="es-ES" sz="1000" dirty="0"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</a:t>
              </a:r>
              <a:r>
                <a:rPr lang="es-ES" sz="1000" dirty="0"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tgagcagctggggctggagagacgacagggctggttgcccagggtccccaggcctctgattcctcactgattgctctt</a:t>
              </a:r>
              <a:r>
                <a:rPr lang="es-ES" sz="1000" dirty="0"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a</a:t>
              </a:r>
              <a:r>
                <a:rPr lang="es-ES" sz="1000" dirty="0"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TCTGGCCCCTCCTCAGCATCTTATCCGAGTGGAAGG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A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AATTTGCGTGTGGAGTATTTGGATGACAGAAACACTTTTCGACATAGTGTGGTGGTGCCCTATGAGCCGCCTG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AG</a:t>
              </a:r>
              <a:r>
                <a:rPr lang="es-ES" sz="1000" dirty="0"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tctggtttgcaactggggtctctgggaggaggggttaagggtggttgtcagtggccctccaggtgagcagtaggggggctttctcctgctgcttatttgacctccctataaccccatgagatgtgcaaagtaaatgggtttaactattgcacagttgaaaaaactgaagcttacagaggctaagggcctcccctgctt</a:t>
              </a:r>
              <a:r>
                <a:rPr lang="es-ES" sz="1000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gctgggcgcagtggctcatgcctgtaatcccagcactttgggaggccaaggcaggcggatcacgaggttgggagatcgagaccatcctggctaacggtgaaaccccgtctctactgaaaaatacaaaaaaaaattagccgggcgtggtgctgggcacctgtagtcccagctactcgggaggctgaggaaggagaatggcgtgaacctgggcggtggagcttgcagtgagctgagatcacgccactgcactccagcctgggcgacagagcgagattccatctcaaaaaaaaaaaaaaaa</a:t>
              </a:r>
              <a:r>
                <a:rPr lang="es-ES" sz="1000" dirty="0"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gcctcccctgcttgccacaggtctccccaaggcgcactggcctcatcttgggcctgtgttatctccta</a:t>
              </a:r>
              <a:r>
                <a:rPr lang="es-ES" sz="1000" dirty="0"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TTGGCTCTGACTGTACCACCATCCACTACAACTACA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T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TGTAACAGTTCCTGCATGGGCGGCATGAACCGGAGGCCCATCCTCACCATCATCACACTGGAAGACTCC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AG</a:t>
              </a:r>
              <a:r>
                <a:rPr lang="es-ES" sz="1000" u="sng" dirty="0"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</a:t>
              </a:r>
              <a:r>
                <a:rPr lang="es-ES" sz="1000" dirty="0"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tcaggagccacttgccaccctgcacactggcctgctgtgccccagcctctgcttgcctctgacccctgggcccacctcttaccgatttcttccatactactacccatccacctctcatcacatccccggcggggaatctccttactgctcccactcagttttcttttctctggctttgggacctcttaacctgtggcttctcctccacctacctggagctggagcttaggctccagaaaggacaagggtggttgggagtagatggagcctggttttttaaatgggacaggtaggacctgatttccttactgcctcttgcttctcttttcctatcctgagta</a:t>
              </a:r>
              <a:r>
                <a:rPr lang="es-ES" sz="1000" dirty="0"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T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TAATCTACTGG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ACGGAACAGCTTT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A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GT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C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TGTTTGTGCCTGTCC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TG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AGAGACCGGCGCACAGAGGAAGAGAATCTCCGCAAGAAAGG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AGCCTCACCACGAGCTGCCCCCAGGGAGCACTAAGCGA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</a:t>
              </a:r>
              <a:r>
                <a:rPr lang="es-ES" sz="1000" dirty="0"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taagcaagcaggacaagaagcggtggaggagaccaagggtgcagttatgcctcagattcacttttatcacctttccttgcctctttcctag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CA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CT</a:t>
              </a:r>
              <a:r>
                <a:rPr lang="es-ES" sz="1000" b="1" dirty="0">
                  <a:solidFill>
                    <a:srgbClr val="C00000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CCCAACAACACCAGCTCCTCTCCCCAGCCAAAGAAGAAACCACTGGATGGAGAATATTTCACCCTTC</a:t>
              </a:r>
              <a:r>
                <a:rPr lang="es-ES" sz="1000" b="1" u="sng" dirty="0">
                  <a:solidFill>
                    <a:srgbClr val="C00000"/>
                  </a:solidFill>
                  <a:effectLst/>
                  <a:highlight>
                    <a:srgbClr val="00FFCC"/>
                  </a:highlight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AG</a:t>
              </a:r>
              <a:r>
                <a:rPr lang="es-ES" sz="1000" dirty="0"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tactaagtcttgggacctcttatcaagtggaaagtttccagtctaacactcaaaatgccgttttcttcttgactgttttacctgcaattggggcatttgccatcagggggcagtgatgcctcaaagacaatggctcctggttgtagctaactaacttcagaacaccaacttataccataatatatattttaaaggaccagaccagctttcaaaaag</a:t>
              </a:r>
              <a:r>
                <a:rPr lang="es-ES" sz="1000" b="1" dirty="0">
                  <a:solidFill>
                    <a:schemeClr val="accent1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GAATTC</a:t>
              </a:r>
            </a:p>
            <a:p>
              <a:pPr algn="just"/>
              <a:r>
                <a:rPr lang="es-ES" sz="1000" b="1" dirty="0">
                  <a:solidFill>
                    <a:srgbClr val="538135"/>
                  </a:solidFill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          </a:t>
              </a:r>
              <a:r>
                <a:rPr lang="es-ES" sz="1000" b="1" dirty="0" err="1">
                  <a:solidFill>
                    <a:schemeClr val="accent1"/>
                  </a:solidFill>
                  <a:effectLst/>
                  <a:latin typeface="Courier New" panose="02070309020205020404" pitchFamily="49" charset="0"/>
                  <a:ea typeface="Cascadia Code" panose="020B0609020000020004" pitchFamily="49" charset="0"/>
                  <a:cs typeface="Courier New" panose="02070309020205020404" pitchFamily="49" charset="0"/>
                </a:rPr>
                <a:t>EcoRI</a:t>
              </a:r>
              <a:endParaRPr lang="en-GB" sz="1000" dirty="0">
                <a:solidFill>
                  <a:schemeClr val="accent1"/>
                </a:solidFill>
                <a:latin typeface="Courier New" panose="02070309020205020404" pitchFamily="49" charset="0"/>
                <a:ea typeface="Cascadia Code" panose="020B06090200000200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5909015" y="766226"/>
              <a:ext cx="4619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solidFill>
                    <a:srgbClr val="C00000"/>
                  </a:solidFill>
                  <a:latin typeface="Abadi" panose="020B0604020104020204" pitchFamily="34" charset="0"/>
                </a:rPr>
                <a:t>ex2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909015" y="1228693"/>
              <a:ext cx="45717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solidFill>
                    <a:srgbClr val="C00000"/>
                  </a:solidFill>
                  <a:latin typeface="Abadi" panose="020B0604020104020204" pitchFamily="34" charset="0"/>
                </a:rPr>
                <a:t>ex3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5909015" y="1772297"/>
              <a:ext cx="45717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solidFill>
                    <a:srgbClr val="C00000"/>
                  </a:solidFill>
                  <a:latin typeface="Abadi" panose="020B0604020104020204" pitchFamily="34" charset="0"/>
                </a:rPr>
                <a:t>ex4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5909015" y="3968631"/>
              <a:ext cx="45717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solidFill>
                    <a:srgbClr val="C00000"/>
                  </a:solidFill>
                  <a:latin typeface="Abadi" panose="020B0604020104020204" pitchFamily="34" charset="0"/>
                </a:rPr>
                <a:t>ex5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909015" y="4507945"/>
              <a:ext cx="50443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solidFill>
                    <a:srgbClr val="C00000"/>
                  </a:solidFill>
                  <a:latin typeface="Abadi" panose="020B0604020104020204" pitchFamily="34" charset="0"/>
                </a:rPr>
                <a:t>ex6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909015" y="6085516"/>
              <a:ext cx="5165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solidFill>
                    <a:srgbClr val="C00000"/>
                  </a:solidFill>
                  <a:latin typeface="Abadi" panose="020B0604020104020204" pitchFamily="34" charset="0"/>
                </a:rPr>
                <a:t>ex7</a:t>
              </a:r>
            </a:p>
          </p:txBody>
        </p:sp>
        <p:sp>
          <p:nvSpPr>
            <p:cNvPr id="31" name="TextBox 9">
              <a:extLst>
                <a:ext uri="{FF2B5EF4-FFF2-40B4-BE49-F238E27FC236}">
                  <a16:creationId xmlns:a16="http://schemas.microsoft.com/office/drawing/2014/main" id="{F448F2C2-33D4-4677-BC80-5BB9CDEB36C2}"/>
                </a:ext>
              </a:extLst>
            </p:cNvPr>
            <p:cNvSpPr txBox="1"/>
            <p:nvPr/>
          </p:nvSpPr>
          <p:spPr>
            <a:xfrm>
              <a:off x="5909015" y="7161983"/>
              <a:ext cx="4619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solidFill>
                    <a:srgbClr val="C00000"/>
                  </a:solidFill>
                  <a:latin typeface="Abadi" panose="020B0604020104020204" pitchFamily="34" charset="0"/>
                </a:rPr>
                <a:t>ex8</a:t>
              </a:r>
            </a:p>
          </p:txBody>
        </p:sp>
        <p:sp>
          <p:nvSpPr>
            <p:cNvPr id="32" name="TextBox 9">
              <a:extLst>
                <a:ext uri="{FF2B5EF4-FFF2-40B4-BE49-F238E27FC236}">
                  <a16:creationId xmlns:a16="http://schemas.microsoft.com/office/drawing/2014/main" id="{7FC3A130-E448-444F-ABA0-8B5037FE1603}"/>
                </a:ext>
              </a:extLst>
            </p:cNvPr>
            <p:cNvSpPr txBox="1"/>
            <p:nvPr/>
          </p:nvSpPr>
          <p:spPr>
            <a:xfrm>
              <a:off x="5909015" y="7525867"/>
              <a:ext cx="45717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solidFill>
                    <a:srgbClr val="C00000"/>
                  </a:solidFill>
                  <a:latin typeface="Abadi" panose="020B0604020104020204" pitchFamily="34" charset="0"/>
                </a:rPr>
                <a:t>ex9</a:t>
              </a:r>
            </a:p>
          </p:txBody>
        </p:sp>
      </p:grpSp>
      <p:sp>
        <p:nvSpPr>
          <p:cNvPr id="33" name="TextBox 16">
            <a:extLst>
              <a:ext uri="{FF2B5EF4-FFF2-40B4-BE49-F238E27FC236}">
                <a16:creationId xmlns:a16="http://schemas.microsoft.com/office/drawing/2014/main" id="{FBA64584-40F1-4FE7-BF34-7B142FBE1BB5}"/>
              </a:ext>
            </a:extLst>
          </p:cNvPr>
          <p:cNvSpPr txBox="1"/>
          <p:nvPr/>
        </p:nvSpPr>
        <p:spPr>
          <a:xfrm>
            <a:off x="117733" y="48677"/>
            <a:ext cx="6622533" cy="1038582"/>
          </a:xfrm>
          <a:prstGeom prst="round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r>
              <a:rPr lang="es-E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s-ES" sz="11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sert</a:t>
            </a:r>
            <a:r>
              <a:rPr lang="es-E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ES" sz="11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equence</a:t>
            </a:r>
            <a:r>
              <a:rPr lang="es-E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ES" sz="11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</a:t>
            </a:r>
            <a:r>
              <a:rPr lang="es-E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ES" sz="11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nigene</a:t>
            </a:r>
            <a:r>
              <a:rPr lang="es-E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gTP53_2-9.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ons are shown in red and upper case, cloning sites (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acI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EcoR1) are indicated in blue, variant nucleotides are green-shadowed and Alu sequences are yellow-shadowed.</a:t>
            </a:r>
            <a:r>
              <a:rPr lang="es-E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E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sert</a:t>
            </a:r>
            <a:r>
              <a:rPr lang="es-E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E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ize</a:t>
            </a:r>
            <a:r>
              <a:rPr lang="es-E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3487 </a:t>
            </a:r>
            <a:r>
              <a:rPr lang="es-E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p</a:t>
            </a:r>
            <a:r>
              <a:rPr lang="es-E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s-E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ructure</a:t>
            </a:r>
            <a:r>
              <a:rPr lang="es-E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s-E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acI</a:t>
            </a:r>
            <a:r>
              <a:rPr lang="es-E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- ivs1 (182 </a:t>
            </a:r>
            <a:r>
              <a:rPr lang="es-E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p</a:t>
            </a:r>
            <a:r>
              <a:rPr lang="es-E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– ex2 (102 </a:t>
            </a:r>
            <a:r>
              <a:rPr lang="es-E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p</a:t>
            </a:r>
            <a:r>
              <a:rPr lang="es-E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– ivs2 (117 </a:t>
            </a:r>
            <a:r>
              <a:rPr lang="es-E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p</a:t>
            </a:r>
            <a:r>
              <a:rPr lang="es-E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– ex3 (22 </a:t>
            </a:r>
            <a:r>
              <a:rPr lang="es-E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p</a:t>
            </a:r>
            <a:r>
              <a:rPr lang="es-E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– ivs3 (109 </a:t>
            </a:r>
            <a:r>
              <a:rPr lang="es-E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p</a:t>
            </a:r>
            <a:r>
              <a:rPr lang="es-E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– ex4 (279 </a:t>
            </a:r>
            <a:r>
              <a:rPr lang="es-E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p</a:t>
            </a:r>
            <a:r>
              <a:rPr lang="es-E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– ivs4 (757 </a:t>
            </a:r>
            <a:r>
              <a:rPr lang="es-E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p</a:t>
            </a:r>
            <a:r>
              <a:rPr lang="es-E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– ex5 (184 </a:t>
            </a:r>
            <a:r>
              <a:rPr lang="es-E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p</a:t>
            </a:r>
            <a:r>
              <a:rPr lang="es-E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– ivs5 (81 </a:t>
            </a:r>
            <a:r>
              <a:rPr lang="es-E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p</a:t>
            </a:r>
            <a:r>
              <a:rPr lang="es-E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– ex6 (113 </a:t>
            </a:r>
            <a:r>
              <a:rPr lang="es-E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p</a:t>
            </a:r>
            <a:r>
              <a:rPr lang="es-E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– iv6 (568 </a:t>
            </a:r>
            <a:r>
              <a:rPr lang="es-E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p</a:t>
            </a:r>
            <a:r>
              <a:rPr lang="es-E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– ex7 (110 </a:t>
            </a:r>
            <a:r>
              <a:rPr lang="es-E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p</a:t>
            </a:r>
            <a:r>
              <a:rPr lang="es-E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– ivs7 (343 </a:t>
            </a:r>
            <a:r>
              <a:rPr lang="es-E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p</a:t>
            </a:r>
            <a:r>
              <a:rPr lang="es-E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– ex8 (137 </a:t>
            </a:r>
            <a:r>
              <a:rPr lang="es-E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p</a:t>
            </a:r>
            <a:r>
              <a:rPr lang="es-E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– ivs8 (92 </a:t>
            </a:r>
            <a:r>
              <a:rPr lang="es-E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p</a:t>
            </a:r>
            <a:r>
              <a:rPr lang="es-E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– ex9 (74 </a:t>
            </a:r>
            <a:r>
              <a:rPr lang="es-E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p</a:t>
            </a:r>
            <a:r>
              <a:rPr lang="es-E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– ivs9 (217 </a:t>
            </a:r>
            <a:r>
              <a:rPr lang="es-E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p</a:t>
            </a:r>
            <a:r>
              <a:rPr lang="es-E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– EcoR1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719617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16CCDFE2EBA6DC4D9A1ADB139F795CFF" ma:contentTypeVersion="16" ma:contentTypeDescription="Crear nuevo documento." ma:contentTypeScope="" ma:versionID="a05ff7a13ec6ca9e5ad35c7849343559">
  <xsd:schema xmlns:xsd="http://www.w3.org/2001/XMLSchema" xmlns:xs="http://www.w3.org/2001/XMLSchema" xmlns:p="http://schemas.microsoft.com/office/2006/metadata/properties" xmlns:ns3="0377925b-fe97-4f83-9e61-45b3838f0cd5" xmlns:ns4="3f2e4a1f-861b-4696-950e-87ad76f524fe" targetNamespace="http://schemas.microsoft.com/office/2006/metadata/properties" ma:root="true" ma:fieldsID="1dce58910d0e20685e5374bb83948924" ns3:_="" ns4:_="">
    <xsd:import namespace="0377925b-fe97-4f83-9e61-45b3838f0cd5"/>
    <xsd:import namespace="3f2e4a1f-861b-4696-950e-87ad76f524fe"/>
    <xsd:element name="properties">
      <xsd:complexType>
        <xsd:sequence>
          <xsd:element name="documentManagement">
            <xsd:complexType>
              <xsd:all>
                <xsd:element ref="ns3:_activity" minOccurs="0"/>
                <xsd:element ref="ns3:MediaServiceMetadata" minOccurs="0"/>
                <xsd:element ref="ns3:MediaServiceFastMetadata" minOccurs="0"/>
                <xsd:element ref="ns3:MediaServiceObjectDetectorVersions" minOccurs="0"/>
                <xsd:element ref="ns3:MediaServiceDateTaken" minOccurs="0"/>
                <xsd:element ref="ns3:MediaServiceAutoTags" minOccurs="0"/>
                <xsd:element ref="ns3:MediaLengthInSeconds" minOccurs="0"/>
                <xsd:element ref="ns3:MediaServiceLocation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377925b-fe97-4f83-9e61-45b3838f0cd5" elementFormDefault="qualified">
    <xsd:import namespace="http://schemas.microsoft.com/office/2006/documentManagement/types"/>
    <xsd:import namespace="http://schemas.microsoft.com/office/infopath/2007/PartnerControls"/>
    <xsd:element name="_activity" ma:index="8" nillable="true" ma:displayName="_activity" ma:hidden="true" ma:internalName="_activity">
      <xsd:simpleType>
        <xsd:restriction base="dms:Note"/>
      </xsd:simpleType>
    </xsd:element>
    <xsd:element name="MediaServiceMetadata" ma:index="9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0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DateTaken" ma:index="12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LengthInSeconds" ma:index="14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15" nillable="true" ma:displayName="Location" ma:indexed="true" ma:internalName="MediaServiceLocation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SystemTags" ma:index="22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3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f2e4a1f-861b-4696-950e-87ad76f524fe" elementFormDefault="qualified">
    <xsd:import namespace="http://schemas.microsoft.com/office/2006/documentManagement/types"/>
    <xsd:import namespace="http://schemas.microsoft.com/office/infopath/2007/PartnerControls"/>
    <xsd:element name="SharedWithUsers" ma:index="19" nillable="true" ma:displayName="Compartid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0" nillable="true" ma:displayName="Detalles de uso compartido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1" nillable="true" ma:displayName="Hash de la sugerencia para comparti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ni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0377925b-fe97-4f83-9e61-45b3838f0cd5" xsi:nil="true"/>
  </documentManagement>
</p:properties>
</file>

<file path=customXml/itemProps1.xml><?xml version="1.0" encoding="utf-8"?>
<ds:datastoreItem xmlns:ds="http://schemas.openxmlformats.org/officeDocument/2006/customXml" ds:itemID="{DED5AFAB-28DC-46C4-8558-F82377416475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1A207797-71A6-427C-9B8F-0F2DA010B15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377925b-fe97-4f83-9e61-45b3838f0cd5"/>
    <ds:schemaRef ds:uri="3f2e4a1f-861b-4696-950e-87ad76f524f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FBA22FB4-C3B3-4BC7-956E-33AB744E79AD}">
  <ds:schemaRefs>
    <ds:schemaRef ds:uri="http://www.w3.org/XML/1998/namespace"/>
    <ds:schemaRef ds:uri="http://purl.org/dc/terms/"/>
    <ds:schemaRef ds:uri="http://schemas.microsoft.com/office/2006/documentManagement/types"/>
    <ds:schemaRef ds:uri="http://purl.org/dc/elements/1.1/"/>
    <ds:schemaRef ds:uri="http://schemas.openxmlformats.org/package/2006/metadata/core-properties"/>
    <ds:schemaRef ds:uri="http://schemas.microsoft.com/office/2006/metadata/properties"/>
    <ds:schemaRef ds:uri="0377925b-fe97-4f83-9e61-45b3838f0cd5"/>
    <ds:schemaRef ds:uri="http://purl.org/dc/dcmitype/"/>
    <ds:schemaRef ds:uri="3f2e4a1f-861b-4696-950e-87ad76f524fe"/>
    <ds:schemaRef ds:uri="http://schemas.microsoft.com/office/infopath/2007/PartnerControl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27</TotalTime>
  <Words>167</Words>
  <Application>Microsoft Macintosh PowerPoint</Application>
  <PresentationFormat>A4 Paper (210x297 mm)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badi</vt:lpstr>
      <vt:lpstr>Arial</vt:lpstr>
      <vt:lpstr>Calibri</vt:lpstr>
      <vt:lpstr>Calibri Light</vt:lpstr>
      <vt:lpstr>Courier New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ena Bueno Martinez</dc:creator>
  <cp:lastModifiedBy>Cristina Fortuno</cp:lastModifiedBy>
  <cp:revision>179</cp:revision>
  <dcterms:created xsi:type="dcterms:W3CDTF">2020-03-02T12:12:44Z</dcterms:created>
  <dcterms:modified xsi:type="dcterms:W3CDTF">2024-12-10T08:45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6CCDFE2EBA6DC4D9A1ADB139F795CFF</vt:lpwstr>
  </property>
</Properties>
</file>